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1446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58E8E6-5F2D-D447-A108-92ADFC0D44CC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D9A925-547A-9B41-9998-9060041CD23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125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B5D92A5-C960-44D4-B28A-32B52BC1128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2498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8854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6686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27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429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9141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2873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0510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5177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3456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5871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9001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843F7-4D96-804A-8FF6-0970C0A8FC78}" type="datetimeFigureOut">
              <a:rPr lang="fr-FR" smtClean="0"/>
              <a:t>18/03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7E482-7EE3-B449-A933-E162CFC1147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1223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B4F5CEC5-3368-480B-A2D5-E00B9D9A60D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029"/>
          <a:stretch/>
        </p:blipFill>
        <p:spPr>
          <a:xfrm>
            <a:off x="0" y="1225808"/>
            <a:ext cx="7738158" cy="3956441"/>
          </a:xfrm>
          <a:prstGeom prst="rect">
            <a:avLst/>
          </a:prstGeom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AE059B83-7A0B-4D95-BB90-E1068343B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45814"/>
            <a:ext cx="7886700" cy="1325563"/>
          </a:xfrm>
        </p:spPr>
        <p:txBody>
          <a:bodyPr/>
          <a:lstStyle/>
          <a:p>
            <a:r>
              <a:rPr lang="en-US" dirty="0"/>
              <a:t>Trace of Oxygraphy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ACE6AB4-F4CA-4988-9B13-2B1054D6550E}"/>
              </a:ext>
            </a:extLst>
          </p:cNvPr>
          <p:cNvSpPr/>
          <p:nvPr/>
        </p:nvSpPr>
        <p:spPr>
          <a:xfrm>
            <a:off x="171637" y="5375039"/>
            <a:ext cx="8683146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Arial"/>
                <a:cs typeface="Arial"/>
              </a:rPr>
              <a:t>The following trace shows the Oxygen concentration slope (nmol/ml) in blue and the Oxygen Slope uncorrected [(</a:t>
            </a:r>
            <a:r>
              <a:rPr lang="en-US" sz="1600" dirty="0" err="1">
                <a:latin typeface="Arial"/>
                <a:cs typeface="Arial"/>
              </a:rPr>
              <a:t>pmol</a:t>
            </a:r>
            <a:r>
              <a:rPr lang="en-US" sz="1600" dirty="0">
                <a:latin typeface="Arial"/>
                <a:cs typeface="Arial"/>
              </a:rPr>
              <a:t>/(s*ml)] in pink over time (min). </a:t>
            </a:r>
            <a:r>
              <a:rPr lang="en-US" sz="1600" dirty="0" err="1">
                <a:latin typeface="Arial"/>
                <a:cs typeface="Arial"/>
              </a:rPr>
              <a:t>MP:Malate</a:t>
            </a:r>
            <a:r>
              <a:rPr lang="en-US" sz="1600" dirty="0">
                <a:latin typeface="Arial"/>
                <a:cs typeface="Arial"/>
              </a:rPr>
              <a:t>/Pyruvate, ADP: Adenosine diphosphate, Glut: Glutamate, </a:t>
            </a:r>
            <a:r>
              <a:rPr lang="en-US" sz="1600" dirty="0" err="1">
                <a:latin typeface="Arial"/>
                <a:cs typeface="Arial"/>
              </a:rPr>
              <a:t>Succ</a:t>
            </a:r>
            <a:r>
              <a:rPr lang="en-US" sz="1600" dirty="0">
                <a:latin typeface="Arial"/>
                <a:cs typeface="Arial"/>
              </a:rPr>
              <a:t>: Succinate, Rot: Rotenone, </a:t>
            </a:r>
            <a:r>
              <a:rPr lang="en-US" sz="1600" dirty="0" err="1">
                <a:latin typeface="Arial"/>
                <a:cs typeface="Arial"/>
              </a:rPr>
              <a:t>Cyt</a:t>
            </a:r>
            <a:r>
              <a:rPr lang="en-US" sz="1600" dirty="0">
                <a:latin typeface="Arial"/>
                <a:cs typeface="Arial"/>
              </a:rPr>
              <a:t> C: Cytochrome C, Oligo: Oligomycin, FCCP: Carbonyl cyanide-4-phenylhydrazone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18D022E-C414-4B0C-A718-4F05BB80EC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83730" y="1277258"/>
            <a:ext cx="999416" cy="3180531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171637" y="162662"/>
            <a:ext cx="5526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Arial"/>
                <a:cs typeface="Arial"/>
              </a:rPr>
              <a:t>S1 </a:t>
            </a:r>
            <a:r>
              <a:rPr lang="fr-FR" b="1" dirty="0" err="1">
                <a:latin typeface="Arial"/>
                <a:cs typeface="Arial"/>
              </a:rPr>
              <a:t>Fig</a:t>
            </a:r>
            <a:endParaRPr lang="fr-FR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462553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7</TotalTime>
  <Words>78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Trace of Oxygraph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ura</dc:creator>
  <cp:lastModifiedBy>SATHISH</cp:lastModifiedBy>
  <cp:revision>15</cp:revision>
  <dcterms:created xsi:type="dcterms:W3CDTF">2020-06-23T12:46:22Z</dcterms:created>
  <dcterms:modified xsi:type="dcterms:W3CDTF">2021-03-18T11:07:57Z</dcterms:modified>
</cp:coreProperties>
</file>